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138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44A90224-9451-4699-8405-B30DE7DC067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Undertittel 2">
            <a:extLst>
              <a:ext uri="{FF2B5EF4-FFF2-40B4-BE49-F238E27FC236}">
                <a16:creationId xmlns:a16="http://schemas.microsoft.com/office/drawing/2014/main" id="{EC1AAC67-95C7-4B39-A364-72A83B52E9A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b-NO"/>
              <a:t>Klikk for å redigere undertittelstil i malen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75D586E0-B203-4C4D-9755-6F57844756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0BC6A-9661-4B87-AF92-705AF6534542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691E0F72-AAFF-4536-BA53-9C1AA6D791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45E7E959-7CA0-45AB-A3E3-B6EA29DAA9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912FF-8845-45D2-84D8-76411E3C8EE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9480997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CBC27007-B3CD-43E8-B3AC-966918B95F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>
            <a:extLst>
              <a:ext uri="{FF2B5EF4-FFF2-40B4-BE49-F238E27FC236}">
                <a16:creationId xmlns:a16="http://schemas.microsoft.com/office/drawing/2014/main" id="{810BA163-321E-4EE1-9F7F-E5CC990CB7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2D6A512B-EF45-4D56-B103-C7A968D266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0BC6A-9661-4B87-AF92-705AF6534542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85E41720-E911-4EEC-9CA0-F8846A8568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FD23526D-0253-44E6-AFA6-6F45F9B55F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912FF-8845-45D2-84D8-76411E3C8EE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888003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drett tittel 1">
            <a:extLst>
              <a:ext uri="{FF2B5EF4-FFF2-40B4-BE49-F238E27FC236}">
                <a16:creationId xmlns:a16="http://schemas.microsoft.com/office/drawing/2014/main" id="{FAB25045-F694-4F4D-A805-A9E0BB5A140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>
            <a:extLst>
              <a:ext uri="{FF2B5EF4-FFF2-40B4-BE49-F238E27FC236}">
                <a16:creationId xmlns:a16="http://schemas.microsoft.com/office/drawing/2014/main" id="{E36DDA20-C618-45DA-B294-FA20107621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6F0B315A-0C9B-4EFB-92AB-8CA3A42DF3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0BC6A-9661-4B87-AF92-705AF6534542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29DCD3D5-B83E-4C76-8FCC-917831865F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73AA2B2D-7BC2-4337-B8E9-078871ECD1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912FF-8845-45D2-84D8-76411E3C8EE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0449210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3BB3B45D-0F41-4E2F-85DD-679BF3B97D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BA61D219-82EB-4724-A1BA-DD7417EC3A0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B368588F-AF78-4DC0-ACFD-26850225A3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0BC6A-9661-4B87-AF92-705AF6534542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72D8641C-2642-4C4B-85E2-7F24305D65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32587852-9EAE-4CDB-A4A4-682910CA0F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912FF-8845-45D2-84D8-76411E3C8EE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4812171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86F93662-3B7E-44B8-A054-8EEC579A11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CB97FBBE-E313-4A15-B04E-03E403CC42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A86179CB-E6BB-4168-83E9-F587F22FF5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0BC6A-9661-4B87-AF92-705AF6534542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4E20A910-9098-4BEF-B193-717DB6F4E0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5DAB10EC-B84F-4723-8E81-E036D4D0DD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912FF-8845-45D2-84D8-76411E3C8EE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1527055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B219877F-F1EF-4BAE-A29C-74B2714C22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C6A7F9ED-2666-461E-B039-FA6BFBA6CB7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CC3F2223-B5A0-488A-863E-6675AD5068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E95CA401-1A85-455D-8BED-F723DCC245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0BC6A-9661-4B87-AF92-705AF6534542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D383376F-E2A7-4CF8-9988-41F31B19C5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20C0EEA3-E614-4BAA-B896-DAC6433A5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912FF-8845-45D2-84D8-76411E3C8EE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9296455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52D4DE6A-A5DA-4A2E-BFD8-0E839A94DB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DD057241-E020-452D-B5ED-1E304A12EC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3417C640-5260-417C-8F2B-6FB7A5C386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tekst 4">
            <a:extLst>
              <a:ext uri="{FF2B5EF4-FFF2-40B4-BE49-F238E27FC236}">
                <a16:creationId xmlns:a16="http://schemas.microsoft.com/office/drawing/2014/main" id="{852E8312-6669-4189-B661-F8BAD8EF6DA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6" name="Plassholder for innhold 5">
            <a:extLst>
              <a:ext uri="{FF2B5EF4-FFF2-40B4-BE49-F238E27FC236}">
                <a16:creationId xmlns:a16="http://schemas.microsoft.com/office/drawing/2014/main" id="{6FCCBA6F-C1CD-4CCC-91D2-97660F868E4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7" name="Plassholder for dato 6">
            <a:extLst>
              <a:ext uri="{FF2B5EF4-FFF2-40B4-BE49-F238E27FC236}">
                <a16:creationId xmlns:a16="http://schemas.microsoft.com/office/drawing/2014/main" id="{91A5DF91-5618-4EB9-B10C-2658FEAD9F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0BC6A-9661-4B87-AF92-705AF6534542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8" name="Plassholder for bunntekst 7">
            <a:extLst>
              <a:ext uri="{FF2B5EF4-FFF2-40B4-BE49-F238E27FC236}">
                <a16:creationId xmlns:a16="http://schemas.microsoft.com/office/drawing/2014/main" id="{2B637453-9BEC-47A4-AAAA-7E279B8C64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Plassholder for lysbildenummer 8">
            <a:extLst>
              <a:ext uri="{FF2B5EF4-FFF2-40B4-BE49-F238E27FC236}">
                <a16:creationId xmlns:a16="http://schemas.microsoft.com/office/drawing/2014/main" id="{BC364244-FAB9-4E1B-830B-6995D1C26A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912FF-8845-45D2-84D8-76411E3C8EE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9475925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ABB795EE-10FC-40D0-A592-6F2639D7A9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dato 2">
            <a:extLst>
              <a:ext uri="{FF2B5EF4-FFF2-40B4-BE49-F238E27FC236}">
                <a16:creationId xmlns:a16="http://schemas.microsoft.com/office/drawing/2014/main" id="{5E69CE61-D49D-4BD9-B481-E26583DB0D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0BC6A-9661-4B87-AF92-705AF6534542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4" name="Plassholder for bunntekst 3">
            <a:extLst>
              <a:ext uri="{FF2B5EF4-FFF2-40B4-BE49-F238E27FC236}">
                <a16:creationId xmlns:a16="http://schemas.microsoft.com/office/drawing/2014/main" id="{CE70BDB6-CC48-41C5-A43F-242423FB6D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Plassholder for lysbildenummer 4">
            <a:extLst>
              <a:ext uri="{FF2B5EF4-FFF2-40B4-BE49-F238E27FC236}">
                <a16:creationId xmlns:a16="http://schemas.microsoft.com/office/drawing/2014/main" id="{FFBDBEF7-E576-4A53-A0AF-413DD7A8E2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912FF-8845-45D2-84D8-76411E3C8EE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701491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>
            <a:extLst>
              <a:ext uri="{FF2B5EF4-FFF2-40B4-BE49-F238E27FC236}">
                <a16:creationId xmlns:a16="http://schemas.microsoft.com/office/drawing/2014/main" id="{75700AEA-B8D3-44C0-8398-121A022A24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0BC6A-9661-4B87-AF92-705AF6534542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3" name="Plassholder for bunntekst 2">
            <a:extLst>
              <a:ext uri="{FF2B5EF4-FFF2-40B4-BE49-F238E27FC236}">
                <a16:creationId xmlns:a16="http://schemas.microsoft.com/office/drawing/2014/main" id="{2C21EE07-DC14-40FC-ADC9-B8566A694D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404C1118-CF2C-42BC-855F-17C00C6630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912FF-8845-45D2-84D8-76411E3C8EE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9661889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268BE508-50D6-4977-B98B-4C782A101A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12863746-2242-47A0-9861-D67B3449285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tekst 3">
            <a:extLst>
              <a:ext uri="{FF2B5EF4-FFF2-40B4-BE49-F238E27FC236}">
                <a16:creationId xmlns:a16="http://schemas.microsoft.com/office/drawing/2014/main" id="{122D3F86-5AB2-4469-9DE1-5F094749A0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7A923FB7-556C-44C8-82F8-F3C780D514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0BC6A-9661-4B87-AF92-705AF6534542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BD834116-89C1-41E4-B8C6-9724B2B274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A9E9A6AA-7BD1-495C-8B85-9654A3BD8F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912FF-8845-45D2-84D8-76411E3C8EE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3443403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7DF4D8F6-E207-4E8D-8759-3BA73D1283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bilde 2">
            <a:extLst>
              <a:ext uri="{FF2B5EF4-FFF2-40B4-BE49-F238E27FC236}">
                <a16:creationId xmlns:a16="http://schemas.microsoft.com/office/drawing/2014/main" id="{67A7AAF6-2CB8-4C63-B4E5-259870B6392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Plassholder for tekst 3">
            <a:extLst>
              <a:ext uri="{FF2B5EF4-FFF2-40B4-BE49-F238E27FC236}">
                <a16:creationId xmlns:a16="http://schemas.microsoft.com/office/drawing/2014/main" id="{13F54BEB-7767-4345-8C06-E1A43C880D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B890983C-B219-4CF1-BCB1-40D1D63879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0BC6A-9661-4B87-AF92-705AF6534542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D6533355-F4E6-4B9E-A900-35ACC80851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928A3356-1E0B-410D-A577-BDDC9E89BB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912FF-8845-45D2-84D8-76411E3C8EE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6445496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ittel 1">
            <a:extLst>
              <a:ext uri="{FF2B5EF4-FFF2-40B4-BE49-F238E27FC236}">
                <a16:creationId xmlns:a16="http://schemas.microsoft.com/office/drawing/2014/main" id="{BBA59AC1-927F-4A63-87F5-627C466619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E273F430-061D-40B1-ABA4-6DC54BA79B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EA7968D3-488B-4E35-AC9D-954CDC7C190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A0BC6A-9661-4B87-AF92-705AF6534542}" type="datetimeFigureOut">
              <a:rPr lang="nb-NO" smtClean="0"/>
              <a:t>19.09.2019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EE8E30CC-B17F-4339-A319-AADC5132F74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5816D6AD-1FD7-4E96-8E23-FDACB2EBDBC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A912FF-8845-45D2-84D8-76411E3C8EE2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3723368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Bilde 4">
            <a:extLst>
              <a:ext uri="{FF2B5EF4-FFF2-40B4-BE49-F238E27FC236}">
                <a16:creationId xmlns:a16="http://schemas.microsoft.com/office/drawing/2014/main" id="{AB92AD7C-CB65-4FA3-A9FB-94501685636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2200" y="61173"/>
            <a:ext cx="7419600" cy="539947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6" name="Rektangel 5">
            <a:extLst>
              <a:ext uri="{FF2B5EF4-FFF2-40B4-BE49-F238E27FC236}">
                <a16:creationId xmlns:a16="http://schemas.microsoft.com/office/drawing/2014/main" id="{CF1EA17D-A678-4E2A-97CF-6F24F1CDEF95}"/>
              </a:ext>
            </a:extLst>
          </p:cNvPr>
          <p:cNvSpPr/>
          <p:nvPr/>
        </p:nvSpPr>
        <p:spPr>
          <a:xfrm>
            <a:off x="807921" y="5355453"/>
            <a:ext cx="8219440" cy="12943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.2. Cumulative incidence of LT according to etiology.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atients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ith ALD are compared to patients with non ALD. The incidence curves were constructed with the Fine and Grey approach treating death as a competing event. </a:t>
            </a:r>
            <a:endParaRPr lang="nb-NO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02339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4</TotalTime>
  <Words>42</Words>
  <Application>Microsoft Office PowerPoint</Application>
  <PresentationFormat>Skjermfremvisning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Brukte skrifter</vt:lpstr>
      </vt:variant>
      <vt:variant>
        <vt:i4>4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-tema</vt:lpstr>
      <vt:lpstr>PowerPoint-presentasj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johnwillyhaukeland@gmail.com</dc:creator>
  <cp:lastModifiedBy> </cp:lastModifiedBy>
  <cp:revision>25</cp:revision>
  <dcterms:created xsi:type="dcterms:W3CDTF">2018-10-17T09:58:29Z</dcterms:created>
  <dcterms:modified xsi:type="dcterms:W3CDTF">2019-09-19T14:29:56Z</dcterms:modified>
</cp:coreProperties>
</file>